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983413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84000" cy="9284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55680" y="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71440" y="696960"/>
            <a:ext cx="4641840" cy="348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b7e7ff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5568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253EED-BDC4-461A-90D1-3BC14BC3CC5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sldImg"/>
          </p:nvPr>
        </p:nvSpPr>
        <p:spPr>
          <a:xfrm>
            <a:off x="1171440" y="696960"/>
            <a:ext cx="4641840" cy="3481200"/>
          </a:xfrm>
          <a:prstGeom prst="rect">
            <a:avLst/>
          </a:prstGeom>
          <a:ln w="0">
            <a:noFill/>
          </a:ln>
        </p:spPr>
      </p:sp>
      <p:sp>
        <p:nvSpPr>
          <p:cNvPr id="59" name="PlaceHolder 2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灯片编号占位符 3"/>
          <p:cNvSpPr/>
          <p:nvPr/>
        </p:nvSpPr>
        <p:spPr>
          <a:xfrm>
            <a:off x="395604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D003AF-4605-4D93-9C7F-7833FAD6C9F3}" type="slidenum">
              <a:rPr b="0" lang="zh-CN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171440" y="696960"/>
            <a:ext cx="4641840" cy="34812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98040" y="4410000"/>
            <a:ext cx="5588280" cy="417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灯片编号占位符 3"/>
          <p:cNvSpPr/>
          <p:nvPr/>
        </p:nvSpPr>
        <p:spPr>
          <a:xfrm>
            <a:off x="3956040" y="8818560"/>
            <a:ext cx="302724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D68B1A-9B04-4CD1-B382-6E3D38CCD975}" type="slidenum">
              <a:rPr b="0" lang="zh-CN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6085B-28CE-4E15-A34C-A47F867D65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854064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1680" y="3986280"/>
            <a:ext cx="854064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A0B62-1D10-4138-9A45-A7165985D6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820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1680" y="398628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8200" y="398628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FEF51-5BDC-41F9-868C-69AD4252FF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89240" y="167616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76800" y="167616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1680" y="398628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89240" y="398628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76800" y="3986280"/>
            <a:ext cx="274968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061C5-ADC4-4B0B-B2FC-EB10E7305A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1680" y="1676160"/>
            <a:ext cx="8540640" cy="4422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7D54E-C3FD-462D-ACC5-85603CFBD7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854064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A7DC3-9BE7-41D1-943B-54937BEC41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416772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8200" y="1676160"/>
            <a:ext cx="416772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F3B74-0F8A-4BD9-A25A-D6A3FBF364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6A3FB-B4B5-4B77-8DB9-006EAA5482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1680" y="228600"/>
            <a:ext cx="85104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8ED7C-AC78-4B8B-99D6-1DAA5EAE18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8200" y="1676160"/>
            <a:ext cx="416772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1680" y="398628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79504-9A15-4D21-8AAB-448496CB35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416772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820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8200" y="398628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CC6A7-1125-43EA-8FB2-F863FBCE9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168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8200" y="1676160"/>
            <a:ext cx="416772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1680" y="3986280"/>
            <a:ext cx="8540640" cy="2109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3885B-54DE-4A1F-8F7F-97FBF7DD6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cc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1680" y="228600"/>
            <a:ext cx="85104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b7e7ff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b7e7ff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1680" y="1676160"/>
            <a:ext cx="8540640" cy="4422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ffff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ff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ffffff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ffcc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ffffff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ffffff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4920" y="6244920"/>
            <a:ext cx="2286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4920"/>
            <a:ext cx="2286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D892ED-959E-43B2-8580-C6C8FED405ED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34920" y="-27000"/>
            <a:ext cx="9109080" cy="41720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9" name=""/>
          <p:cNvGraphicFramePr/>
          <p:nvPr/>
        </p:nvGraphicFramePr>
        <p:xfrm>
          <a:off x="179280" y="4437000"/>
          <a:ext cx="8663040" cy="1317600"/>
        </p:xfrm>
        <a:graphic>
          <a:graphicData uri="http://schemas.openxmlformats.org/drawingml/2006/table">
            <a:tbl>
              <a:tblPr/>
              <a:tblGrid>
                <a:gridCol w="571680"/>
                <a:gridCol w="449280"/>
                <a:gridCol w="449280"/>
                <a:gridCol w="450720"/>
                <a:gridCol w="449280"/>
                <a:gridCol w="449280"/>
                <a:gridCol w="449280"/>
                <a:gridCol w="449280"/>
                <a:gridCol w="449280"/>
                <a:gridCol w="450720"/>
                <a:gridCol w="449280"/>
                <a:gridCol w="449280"/>
                <a:gridCol w="449280"/>
                <a:gridCol w="449280"/>
                <a:gridCol w="449280"/>
                <a:gridCol w="450720"/>
                <a:gridCol w="449280"/>
                <a:gridCol w="449280"/>
                <a:gridCol w="449280"/>
              </a:tblGrid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8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r>
                        <a:rPr b="1" lang="en-US" sz="11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NP position within the 489 nt fragment</a:t>
                      </a:r>
                      <a:endParaRPr b="0" lang="en-US" sz="11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98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99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0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07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2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23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25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31</a:t>
                      </a:r>
                      <a:endParaRPr b="0" lang="en-US" sz="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34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63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70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75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77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43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53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7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07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2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ES208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</a:tr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LA-Purple</a:t>
                      </a:r>
                      <a:endParaRPr b="0" lang="en-US" sz="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Molokai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876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9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r>
                        <a:rPr b="1" lang="zh-CN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6480" y="-71280"/>
            <a:ext cx="9145440" cy="4554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1" name=""/>
          <p:cNvGraphicFramePr/>
          <p:nvPr/>
        </p:nvGraphicFramePr>
        <p:xfrm>
          <a:off x="684360" y="4740120"/>
          <a:ext cx="7543800" cy="1857600"/>
        </p:xfrm>
        <a:graphic>
          <a:graphicData uri="http://schemas.openxmlformats.org/drawingml/2006/table">
            <a:tbl>
              <a:tblPr/>
              <a:tblGrid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</a:tblGrid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9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　</a:t>
                      </a: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SNP position within SuSy2 (Ay118266.1)</a:t>
                      </a: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4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　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521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574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622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684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740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748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860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870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870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894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ES208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33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LA Purple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</a:tr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Molokai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ffffff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　</a:t>
                      </a:r>
                      <a:r>
                        <a:rPr b="1" lang="en-US" sz="16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0" y="0"/>
            <a:ext cx="9109080" cy="4581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3" name=""/>
          <p:cNvGraphicFramePr/>
          <p:nvPr/>
        </p:nvGraphicFramePr>
        <p:xfrm>
          <a:off x="395280" y="4724280"/>
          <a:ext cx="8291520" cy="1886040"/>
        </p:xfrm>
        <a:graphic>
          <a:graphicData uri="http://schemas.openxmlformats.org/drawingml/2006/table">
            <a:tbl>
              <a:tblPr/>
              <a:tblGrid>
                <a:gridCol w="74772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</a:tblGrid>
              <a:tr h="295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1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NP position within the 569 nt fragment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4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54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92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159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182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299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43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53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63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66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482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508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SES208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LA Purple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2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Molokai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</a:tr>
              <a:tr h="303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Intron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　</a:t>
                      </a: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Extron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6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10"/>
                          </a:solidFill>
                          <a:latin typeface="宋体"/>
                        </a:rPr>
                        <a:t>Extron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"/>
          <p:cNvPicPr/>
          <p:nvPr/>
        </p:nvPicPr>
        <p:blipFill>
          <a:blip r:embed="rId1"/>
          <a:stretch/>
        </p:blipFill>
        <p:spPr>
          <a:xfrm>
            <a:off x="-20520" y="0"/>
            <a:ext cx="8886600" cy="42768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5" name=""/>
          <p:cNvGraphicFramePr/>
          <p:nvPr/>
        </p:nvGraphicFramePr>
        <p:xfrm>
          <a:off x="157320" y="4437000"/>
          <a:ext cx="8735760" cy="1500120"/>
        </p:xfrm>
        <a:graphic>
          <a:graphicData uri="http://schemas.openxmlformats.org/drawingml/2006/table">
            <a:tbl>
              <a:tblPr/>
              <a:tblGrid>
                <a:gridCol w="644400"/>
                <a:gridCol w="449280"/>
                <a:gridCol w="449280"/>
                <a:gridCol w="449280"/>
                <a:gridCol w="449280"/>
                <a:gridCol w="450720"/>
                <a:gridCol w="449280"/>
                <a:gridCol w="449280"/>
                <a:gridCol w="449280"/>
                <a:gridCol w="449280"/>
                <a:gridCol w="449280"/>
                <a:gridCol w="449280"/>
                <a:gridCol w="450720"/>
                <a:gridCol w="449280"/>
                <a:gridCol w="449280"/>
                <a:gridCol w="449280"/>
                <a:gridCol w="449280"/>
                <a:gridCol w="449280"/>
                <a:gridCol w="450720"/>
              </a:tblGrid>
              <a:tr h="25020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9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NP position within 470 nt fragment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984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0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59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6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66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04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20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40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42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69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17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27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61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33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34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52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67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68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33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020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ES208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</a:tr>
              <a:tr h="24984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LA Purple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020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Molokai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</a:tr>
              <a:tr h="24984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r>
                        <a:rPr b="1" lang="zh-CN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endParaRPr b="0" lang="en-US" sz="9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ffffff"/>
                          </a:solidFill>
                          <a:latin typeface="宋体"/>
                        </a:rPr>
                        <a:t>　</a:t>
                      </a:r>
                      <a:endParaRPr b="0" lang="en-US" sz="10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93600" y="44280"/>
            <a:ext cx="9086760" cy="35053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7" name=""/>
          <p:cNvGraphicFramePr/>
          <p:nvPr/>
        </p:nvGraphicFramePr>
        <p:xfrm>
          <a:off x="1042920" y="3905280"/>
          <a:ext cx="6958080" cy="1895400"/>
        </p:xfrm>
        <a:graphic>
          <a:graphicData uri="http://schemas.openxmlformats.org/drawingml/2006/table">
            <a:tbl>
              <a:tblPr/>
              <a:tblGrid>
                <a:gridCol w="78588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  <a:gridCol w="685800"/>
              </a:tblGrid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NP position within 577 nt fragment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35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5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71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12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122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20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251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40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459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SES208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LA Purple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Molokai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69696"/>
                    </a:solidFill>
                  </a:tcPr>
                </a:tc>
              </a:tr>
              <a:tr h="3049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Extron</a:t>
                      </a:r>
                      <a:r>
                        <a:rPr b="1" lang="zh-CN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　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ff0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100100"/>
                          </a:solidFill>
                          <a:latin typeface="宋体"/>
                        </a:rPr>
                        <a:t>Intron</a:t>
                      </a:r>
                      <a:endParaRPr b="0" lang="en-US" sz="12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6:09:23Z</dcterms:created>
  <dc:creator>zjs</dc:creator>
  <dc:description/>
  <dc:language>en-US</dc:language>
  <cp:lastModifiedBy>tclsevers</cp:lastModifiedBy>
  <dcterms:modified xsi:type="dcterms:W3CDTF">2012-10-30T06:47:21Z</dcterms:modified>
  <cp:revision>157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9</vt:r8>
  </property>
</Properties>
</file>